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5"/>
  </p:notesMasterIdLst>
  <p:sldIdLst>
    <p:sldId id="282" r:id="rId2"/>
    <p:sldId id="285" r:id="rId3"/>
    <p:sldId id="288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101"/>
    <p:restoredTop sz="94762"/>
  </p:normalViewPr>
  <p:slideViewPr>
    <p:cSldViewPr snapToGrid="0" snapToObjects="1">
      <p:cViewPr varScale="1">
        <p:scale>
          <a:sx n="106" d="100"/>
          <a:sy n="106" d="100"/>
        </p:scale>
        <p:origin x="672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E09CDA-6211-F743-BDB3-B43925261D7A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6C1B343-DB24-734A-B7AD-93FCA64AD18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734109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F505CA0-2043-ADDB-F204-B6D51FD002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F7812BF-DAC4-DC58-B214-6BDC8455827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EFAF470-652E-9493-1039-1AFD40A01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54AD417-1C88-AD4F-66DD-281F71E2F5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E363C7-DA25-6D73-BB53-362FFA89C2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6345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78ABA56-A042-870E-A6B0-1C96097DD2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6EEB32E-D503-DD4A-C3AE-5CE21938656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21A3C4A-5130-94EE-CB17-F431CFC6E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CBE7434-82B7-BBC9-C9FD-69D9B9B209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99C4B95-8473-746E-5292-498F81C50E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1736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CE324C21-E993-A267-5FCE-52D51C50EA0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0D61099-E7FB-949F-C239-C31838EFB48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2B73F46-1A40-D709-D6DC-0EAA1A2084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F1F523D-711B-3479-5FDB-60E02503D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A943F85-C042-4CE5-D10A-2DDF927EE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55825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E071842-ED6F-20C6-1700-BE7C3A0B9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FF2DB78-14D3-9755-772A-7A0DE341CA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70D121-183F-93FA-8C76-D60A9074C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1B7CFD0-42F8-9C70-708D-2B6A47AD39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830BB8F-5D96-8B48-954E-6ACB5EB0A4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4401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802CA43-5812-3E6F-6891-ECC6C84593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E1451F6-85F8-5B57-C23A-B56DD20E29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7A7A7BD-4903-8891-61C8-404A9C4087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62FF190-DCC4-8420-940C-02502DB390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2754FAA-1B1D-09FD-9B13-8D30CE7A4A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49504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B948F4-CFED-33E6-21D8-AC48068820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A2EDB03-CAEB-DFA5-F1C5-808E30D5D62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A594A52-1D00-2AED-8207-4188F8D40B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9839867-6F00-6258-67F7-BE7B13AF7E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A4A1E59-C457-790A-3C64-89A1ABFE86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7CE398CF-1C59-F2B3-B11E-D19D34149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6176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C74867-A0AB-F972-1A58-DABC8B57E5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E873EBC-D7FA-9C89-0F03-182C93CC92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738FF90B-A68E-CD9C-B457-698F7B0A4A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231B82B-D919-9BD5-F936-7D882453D1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BADC9AFA-65E8-3AE5-002C-AE85D18E92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A3D17D0B-813F-4D0A-1316-A3D80EF57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64E4320B-1AFE-23AD-63A6-334833254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EFD3C6B-B2A7-91C4-68CA-F9C51A38C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95157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8EF6355-DA98-3014-C384-C98C2B586E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5038BE1-EB19-5BCC-BA8E-10E11593FD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9ABA96E5-2E37-76E6-5B98-9DCEA70A00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73571D62-0CB1-9C0F-A70A-F966EC420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2740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9C20ECE-404E-DBFC-B117-99B487BFD3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2DD03C0-4DB3-64C8-0A6B-DAD3FF054B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73AFE1D-78AF-2179-4B4D-F453F5B238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398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793B0B-8092-A1A8-1AEF-76DE817127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0C27477-E09B-E6EA-5596-E9CF7BEF99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35DB97A-F573-DEA3-7900-0BD9D72B7C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5DFA283-8C3F-08B1-57AA-C73F98898B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C7A5006-3FAD-8DDE-E181-38E452AFA6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045A626-031D-17F7-2181-3717A8777F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5920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24468B-52AD-AD2C-3846-FA31A2BA5F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C138150B-6435-A037-0C09-43CBC320B2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B0CCC165-D5B0-C206-2F7E-135D2CC280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6210975-5344-1C9B-1219-ED459682DB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A91DE80-0AD8-C8A8-29FD-F1ED6314BB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8D07D6F-8063-1527-3A7A-A56B9B668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0039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64E68670-735D-56E2-4178-0239928D32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2DFAA505-C224-988B-D3A2-70144DFB9A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77E4DAA-2BCF-9696-195C-C0AD7A898CA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07F42-C621-BE49-A711-8F4E011DDA60}" type="datetimeFigureOut">
              <a:rPr kumimoji="1" lang="ja-JP" altLang="en-US" smtClean="0"/>
              <a:t>2022/5/2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BD0999E-6939-FE54-0282-FE439830A3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EF85C61-F3FB-917B-4350-26B2091103A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33D8EA0-DA83-8A42-969A-6D05B642FE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72827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jpg"/><Relationship Id="rId5" Type="http://schemas.openxmlformats.org/officeDocument/2006/relationships/image" Target="../media/image6.jpg"/><Relationship Id="rId4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84C991A-8877-79D0-1A40-4BAD8DB91888}"/>
              </a:ext>
            </a:extLst>
          </p:cNvPr>
          <p:cNvSpPr txBox="1"/>
          <p:nvPr/>
        </p:nvSpPr>
        <p:spPr>
          <a:xfrm>
            <a:off x="3946886" y="340621"/>
            <a:ext cx="129663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Liver</a:t>
            </a:r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 (x200)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5383EF0A-75E9-FE4A-C38E-DDB37A19C02B}"/>
              </a:ext>
            </a:extLst>
          </p:cNvPr>
          <p:cNvGrpSpPr/>
          <p:nvPr/>
        </p:nvGrpSpPr>
        <p:grpSpPr>
          <a:xfrm>
            <a:off x="1479123" y="777048"/>
            <a:ext cx="6227963" cy="5351251"/>
            <a:chOff x="1479123" y="976744"/>
            <a:chExt cx="6227963" cy="5351251"/>
          </a:xfrm>
        </p:grpSpPr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21B7FC25-B98E-B6DE-8FC6-076C009756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79123" y="976744"/>
              <a:ext cx="6227962" cy="5351251"/>
            </a:xfrm>
            <a:prstGeom prst="rect">
              <a:avLst/>
            </a:prstGeom>
          </p:spPr>
        </p:pic>
        <p:grpSp>
          <p:nvGrpSpPr>
            <p:cNvPr id="12" name="グループ化 11">
              <a:extLst>
                <a:ext uri="{FF2B5EF4-FFF2-40B4-BE49-F238E27FC236}">
                  <a16:creationId xmlns:a16="http://schemas.microsoft.com/office/drawing/2014/main" id="{908282AD-B57A-4D81-E221-BE48C1A2DF20}"/>
                </a:ext>
              </a:extLst>
            </p:cNvPr>
            <p:cNvGrpSpPr/>
            <p:nvPr/>
          </p:nvGrpSpPr>
          <p:grpSpPr>
            <a:xfrm>
              <a:off x="6308726" y="5975841"/>
              <a:ext cx="1398360" cy="352154"/>
              <a:chOff x="6204642" y="6360632"/>
              <a:chExt cx="1294707" cy="352154"/>
            </a:xfrm>
          </p:grpSpPr>
          <p:sp>
            <p:nvSpPr>
              <p:cNvPr id="6" name="正方形/長方形 5">
                <a:extLst>
                  <a:ext uri="{FF2B5EF4-FFF2-40B4-BE49-F238E27FC236}">
                    <a16:creationId xmlns:a16="http://schemas.microsoft.com/office/drawing/2014/main" id="{A36F61B3-A06F-C587-03E3-6671122FB7CB}"/>
                  </a:ext>
                </a:extLst>
              </p:cNvPr>
              <p:cNvSpPr/>
              <p:nvPr/>
            </p:nvSpPr>
            <p:spPr>
              <a:xfrm>
                <a:off x="6204642" y="6360632"/>
                <a:ext cx="1294707" cy="352154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7" name="グループ化 6">
                <a:extLst>
                  <a:ext uri="{FF2B5EF4-FFF2-40B4-BE49-F238E27FC236}">
                    <a16:creationId xmlns:a16="http://schemas.microsoft.com/office/drawing/2014/main" id="{A2C8BE7F-6A1F-70EC-9119-D72F7F0FB90A}"/>
                  </a:ext>
                </a:extLst>
              </p:cNvPr>
              <p:cNvGrpSpPr/>
              <p:nvPr/>
            </p:nvGrpSpPr>
            <p:grpSpPr>
              <a:xfrm>
                <a:off x="6287193" y="6388322"/>
                <a:ext cx="1104207" cy="286524"/>
                <a:chOff x="10288976" y="3479900"/>
                <a:chExt cx="1104207" cy="286524"/>
              </a:xfrm>
            </p:grpSpPr>
            <p:sp>
              <p:nvSpPr>
                <p:cNvPr id="8" name="正方形/長方形 7">
                  <a:extLst>
                    <a:ext uri="{FF2B5EF4-FFF2-40B4-BE49-F238E27FC236}">
                      <a16:creationId xmlns:a16="http://schemas.microsoft.com/office/drawing/2014/main" id="{CC556A86-C00F-99D2-B9BA-9BE0FFA11A72}"/>
                    </a:ext>
                  </a:extLst>
                </p:cNvPr>
                <p:cNvSpPr/>
                <p:nvPr/>
              </p:nvSpPr>
              <p:spPr>
                <a:xfrm>
                  <a:off x="10288976" y="3527365"/>
                  <a:ext cx="569583" cy="23905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cxnSp>
              <p:nvCxnSpPr>
                <p:cNvPr id="9" name="直線コネクタ 8">
                  <a:extLst>
                    <a:ext uri="{FF2B5EF4-FFF2-40B4-BE49-F238E27FC236}">
                      <a16:creationId xmlns:a16="http://schemas.microsoft.com/office/drawing/2014/main" id="{EDE97BA8-BAD4-6116-D749-0194D1B350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0310150" y="3734115"/>
                  <a:ext cx="1083033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" name="テキスト ボックス 9">
                  <a:extLst>
                    <a:ext uri="{FF2B5EF4-FFF2-40B4-BE49-F238E27FC236}">
                      <a16:creationId xmlns:a16="http://schemas.microsoft.com/office/drawing/2014/main" id="{08E89FD3-522E-108D-5F51-6929C75853C7}"/>
                    </a:ext>
                  </a:extLst>
                </p:cNvPr>
                <p:cNvSpPr txBox="1"/>
                <p:nvPr/>
              </p:nvSpPr>
              <p:spPr>
                <a:xfrm>
                  <a:off x="10472185" y="3479900"/>
                  <a:ext cx="74251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b="1" dirty="0"/>
                    <a:t>100</a:t>
                  </a:r>
                  <a:r>
                    <a:rPr kumimoji="1" lang="en-US" altLang="ja-JP" sz="1200" b="1" dirty="0"/>
                    <a:t>μm</a:t>
                  </a:r>
                  <a:endParaRPr kumimoji="1" lang="ja-JP" altLang="en-US" sz="1200" b="1"/>
                </a:p>
              </p:txBody>
            </p:sp>
          </p:grpSp>
        </p:grpSp>
      </p:grp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B3CF7DC5-EBE2-1ADB-1119-EB14FD3D157C}"/>
              </a:ext>
            </a:extLst>
          </p:cNvPr>
          <p:cNvSpPr txBox="1"/>
          <p:nvPr/>
        </p:nvSpPr>
        <p:spPr>
          <a:xfrm>
            <a:off x="3120675" y="6183495"/>
            <a:ext cx="30251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T</a:t>
            </a:r>
            <a:r>
              <a:rPr lang="en-US" altLang="ja-JP" sz="1200" dirty="0"/>
              <a:t>he picture of positive control for DFS.</a:t>
            </a:r>
            <a:r>
              <a:rPr lang="ja-JP" altLang="ja-JP" sz="1200"/>
              <a:t> </a:t>
            </a:r>
            <a:r>
              <a:rPr kumimoji="1" lang="en-US" altLang="ja-JP" sz="1200" dirty="0"/>
              <a:t> </a:t>
            </a:r>
            <a:endParaRPr kumimoji="1" lang="ja-JP" altLang="en-US" sz="12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DC6765E4-51E4-7879-98C4-98A0133141EB}"/>
              </a:ext>
            </a:extLst>
          </p:cNvPr>
          <p:cNvSpPr txBox="1"/>
          <p:nvPr/>
        </p:nvSpPr>
        <p:spPr>
          <a:xfrm>
            <a:off x="112794" y="133768"/>
            <a:ext cx="28729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l Figure S1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768870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FF5EB08-54BF-DF5B-F7A9-7B55631CC4C8}"/>
              </a:ext>
            </a:extLst>
          </p:cNvPr>
          <p:cNvSpPr txBox="1"/>
          <p:nvPr/>
        </p:nvSpPr>
        <p:spPr>
          <a:xfrm>
            <a:off x="819223" y="5255191"/>
            <a:ext cx="1070011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/>
              <a:t>KCASP1Tg mice showed elevated expression of cytokines such as TNF-α, IL-17A, IL-23 from 8 to 16 weeks in the dorsal skin.</a:t>
            </a:r>
          </a:p>
          <a:p>
            <a:endParaRPr lang="en-US" altLang="ja-JP" sz="1200" dirty="0"/>
          </a:p>
          <a:p>
            <a:r>
              <a:rPr lang="en-US" altLang="ja-JP" sz="1200" dirty="0"/>
              <a:t>The cytokines expressions in the skin of 0, 8, 16-week-old KCASP1Tg mice were performed (n=5 per group). From 8 to 16 weeks, the concentration of TNF-α, IL-17A, IL-23 were elevated in KCASP1Tg mice with significance (p values; TNF-α, 0.0030; IL-17A, 0.0020; IL-23, 0.0018, respectively). </a:t>
            </a:r>
          </a:p>
          <a:p>
            <a:r>
              <a:rPr lang="en-US" altLang="ja-JP" sz="1200" dirty="0"/>
              <a:t>Values are presented as mean ± SD, and statistically significant differences (*P&lt; 0.05, **P&lt; 0.01).</a:t>
            </a:r>
          </a:p>
        </p:txBody>
      </p:sp>
      <p:pic>
        <p:nvPicPr>
          <p:cNvPr id="13" name="図 12">
            <a:extLst>
              <a:ext uri="{FF2B5EF4-FFF2-40B4-BE49-F238E27FC236}">
                <a16:creationId xmlns:a16="http://schemas.microsoft.com/office/drawing/2014/main" id="{CD896D7F-10EE-9BCC-E597-78E39A9C79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22379" y="1418894"/>
            <a:ext cx="8947241" cy="3373821"/>
          </a:xfrm>
          <a:prstGeom prst="rect">
            <a:avLst/>
          </a:prstGeom>
        </p:spPr>
      </p:pic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64ECC316-164C-E5D1-51BA-5AAE8C130CD9}"/>
              </a:ext>
            </a:extLst>
          </p:cNvPr>
          <p:cNvSpPr txBox="1"/>
          <p:nvPr/>
        </p:nvSpPr>
        <p:spPr>
          <a:xfrm>
            <a:off x="4745500" y="980582"/>
            <a:ext cx="228697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Cytokines expressions (Skin)</a:t>
            </a:r>
            <a:endParaRPr kumimoji="1" lang="ja-JP" altLang="en-US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00C6A43-A724-ED09-39F7-C7530CC710D6}"/>
              </a:ext>
            </a:extLst>
          </p:cNvPr>
          <p:cNvSpPr txBox="1"/>
          <p:nvPr/>
        </p:nvSpPr>
        <p:spPr>
          <a:xfrm>
            <a:off x="112794" y="133768"/>
            <a:ext cx="28729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l Figure S2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28655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87AA08EE-E244-667E-4D1E-10D14182AA4F}"/>
              </a:ext>
            </a:extLst>
          </p:cNvPr>
          <p:cNvSpPr txBox="1"/>
          <p:nvPr/>
        </p:nvSpPr>
        <p:spPr>
          <a:xfrm>
            <a:off x="112794" y="133768"/>
            <a:ext cx="28729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b="1" dirty="0"/>
              <a:t>Supplemental </a:t>
            </a:r>
            <a:r>
              <a:rPr lang="en-US" altLang="ja-JP" b="1"/>
              <a:t>Figure S3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976EB83-4997-5F88-A835-D1761FA58012}"/>
              </a:ext>
            </a:extLst>
          </p:cNvPr>
          <p:cNvSpPr txBox="1"/>
          <p:nvPr/>
        </p:nvSpPr>
        <p:spPr>
          <a:xfrm>
            <a:off x="706531" y="498905"/>
            <a:ext cx="10054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Skin (x100)</a:t>
            </a:r>
            <a:endParaRPr kumimoji="1" lang="ja-JP" altLang="en-US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図 5" descr="テキスト, 地図 が含まれている画像&#10;&#10;自動的に生成された説明">
            <a:extLst>
              <a:ext uri="{FF2B5EF4-FFF2-40B4-BE49-F238E27FC236}">
                <a16:creationId xmlns:a16="http://schemas.microsoft.com/office/drawing/2014/main" id="{0090C474-2C48-207B-8822-1EF347D8F0F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447" y="1066311"/>
            <a:ext cx="2657462" cy="1795582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E23437CC-DDA0-1BB2-36FC-CFB82439BB3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62758" y="1066311"/>
            <a:ext cx="2633520" cy="1795582"/>
          </a:xfrm>
          <a:prstGeom prst="rect">
            <a:avLst/>
          </a:prstGeom>
        </p:spPr>
      </p:pic>
      <p:pic>
        <p:nvPicPr>
          <p:cNvPr id="8" name="図 7" descr="背景パターン が含まれている画像&#10;&#10;自動的に生成された説明">
            <a:extLst>
              <a:ext uri="{FF2B5EF4-FFF2-40B4-BE49-F238E27FC236}">
                <a16:creationId xmlns:a16="http://schemas.microsoft.com/office/drawing/2014/main" id="{838DD858-BED3-88B6-D2AB-BD415C0A333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9999" y="3255459"/>
            <a:ext cx="2657462" cy="1795582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1B9B6039-C370-F9D0-66C1-29BC705D772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5311" y="3292975"/>
            <a:ext cx="2645490" cy="1783611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11CE507-8B88-0698-83E1-63F04E40CD9A}"/>
              </a:ext>
            </a:extLst>
          </p:cNvPr>
          <p:cNvSpPr txBox="1"/>
          <p:nvPr/>
        </p:nvSpPr>
        <p:spPr>
          <a:xfrm>
            <a:off x="1044028" y="817370"/>
            <a:ext cx="125566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w</a:t>
            </a:r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ild /16-week</a:t>
            </a:r>
            <a:endParaRPr kumimoji="1" lang="ja-JP" altLang="en-US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3B8E8E9-90AC-82ED-7DDD-DB490E14CB1C}"/>
              </a:ext>
            </a:extLst>
          </p:cNvPr>
          <p:cNvSpPr txBox="1"/>
          <p:nvPr/>
        </p:nvSpPr>
        <p:spPr>
          <a:xfrm>
            <a:off x="3823112" y="817369"/>
            <a:ext cx="1649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KCASP1Tg /16-week</a:t>
            </a:r>
            <a:endParaRPr kumimoji="1" lang="ja-JP" altLang="en-US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CDFD7F0-F321-14CA-C2EB-7EAB733BFA48}"/>
              </a:ext>
            </a:extLst>
          </p:cNvPr>
          <p:cNvSpPr txBox="1"/>
          <p:nvPr/>
        </p:nvSpPr>
        <p:spPr>
          <a:xfrm>
            <a:off x="599439" y="2997655"/>
            <a:ext cx="22985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Treated </a:t>
            </a:r>
            <a:r>
              <a:rPr kumimoji="1" lang="en-US" altLang="ja-JP" sz="1400" b="1" dirty="0" err="1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  <a:r>
              <a:rPr lang="en-US" altLang="ja-JP" sz="1400" b="1" dirty="0" err="1">
                <a:latin typeface="Calibri" panose="020F0502020204030204" pitchFamily="34" charset="0"/>
                <a:cs typeface="Calibri" panose="020F0502020204030204" pitchFamily="34" charset="0"/>
              </a:rPr>
              <a:t>aricitinib</a:t>
            </a:r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 /16-week</a:t>
            </a:r>
            <a:endParaRPr kumimoji="1" lang="ja-JP" altLang="en-US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313CDD8-3DFB-8CB8-871D-1A424AC9CA69}"/>
              </a:ext>
            </a:extLst>
          </p:cNvPr>
          <p:cNvSpPr txBox="1"/>
          <p:nvPr/>
        </p:nvSpPr>
        <p:spPr>
          <a:xfrm>
            <a:off x="3514169" y="2997655"/>
            <a:ext cx="24357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Treated </a:t>
            </a:r>
            <a:r>
              <a:rPr kumimoji="1" lang="en-US" altLang="ja-JP" sz="1400" b="1" dirty="0" err="1">
                <a:latin typeface="Calibri" panose="020F0502020204030204" pitchFamily="34" charset="0"/>
                <a:cs typeface="Calibri" panose="020F0502020204030204" pitchFamily="34" charset="0"/>
              </a:rPr>
              <a:t>c</a:t>
            </a:r>
            <a:r>
              <a:rPr lang="en-US" altLang="ja-JP" sz="1400" b="1" dirty="0" err="1">
                <a:latin typeface="Calibri" panose="020F0502020204030204" pitchFamily="34" charset="0"/>
                <a:cs typeface="Calibri" panose="020F0502020204030204" pitchFamily="34" charset="0"/>
              </a:rPr>
              <a:t>erdulatinib</a:t>
            </a:r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 /16-week</a:t>
            </a:r>
            <a:endParaRPr kumimoji="1" lang="ja-JP" altLang="en-US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FA52B2E9-37A8-14AC-9981-E12A66E51807}"/>
              </a:ext>
            </a:extLst>
          </p:cNvPr>
          <p:cNvSpPr txBox="1"/>
          <p:nvPr/>
        </p:nvSpPr>
        <p:spPr>
          <a:xfrm>
            <a:off x="6460795" y="471705"/>
            <a:ext cx="4523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79D0638E-6C89-3EF7-3EA5-8118CB8E28AE}"/>
              </a:ext>
            </a:extLst>
          </p:cNvPr>
          <p:cNvSpPr txBox="1"/>
          <p:nvPr/>
        </p:nvSpPr>
        <p:spPr>
          <a:xfrm>
            <a:off x="254389" y="471705"/>
            <a:ext cx="4427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endParaRPr kumimoji="1" lang="ja-JP" altLang="en-US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23" name="図 22" descr="グラフ&#10;&#10;自動的に生成された説明">
            <a:extLst>
              <a:ext uri="{FF2B5EF4-FFF2-40B4-BE49-F238E27FC236}">
                <a16:creationId xmlns:a16="http://schemas.microsoft.com/office/drawing/2014/main" id="{DDDC9279-A44F-6F2C-13CE-84BA3D91DC2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025850" y="862107"/>
            <a:ext cx="2983719" cy="4025205"/>
          </a:xfrm>
          <a:prstGeom prst="rect">
            <a:avLst/>
          </a:prstGeom>
        </p:spPr>
      </p:pic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CF2C7919-C94B-0E63-B992-7F399731C22C}"/>
              </a:ext>
            </a:extLst>
          </p:cNvPr>
          <p:cNvSpPr txBox="1"/>
          <p:nvPr/>
        </p:nvSpPr>
        <p:spPr>
          <a:xfrm>
            <a:off x="7070505" y="519924"/>
            <a:ext cx="54207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>
                <a:latin typeface="Calibri" panose="020F0502020204030204" pitchFamily="34" charset="0"/>
                <a:cs typeface="Calibri" panose="020F0502020204030204" pitchFamily="34" charset="0"/>
              </a:rPr>
              <a:t>Liver</a:t>
            </a:r>
            <a:endParaRPr kumimoji="1" lang="ja-JP" altLang="en-US" sz="1400" b="1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5A32AEE-8237-F5FF-71DC-567321E34EDC}"/>
              </a:ext>
            </a:extLst>
          </p:cNvPr>
          <p:cNvSpPr txBox="1"/>
          <p:nvPr/>
        </p:nvSpPr>
        <p:spPr>
          <a:xfrm>
            <a:off x="115200" y="5091569"/>
            <a:ext cx="1201373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ja-JP" altLang="en-US" sz="1200" b="1"/>
              <a:t>Histological analysis showed </a:t>
            </a:r>
            <a:r>
              <a:rPr lang="en-US" altLang="ja-JP" sz="1200" b="1" dirty="0"/>
              <a:t>cutaneous inflammation</a:t>
            </a:r>
            <a:r>
              <a:rPr lang="ja-JP" altLang="en-US" sz="1200" b="1"/>
              <a:t> was improved by </a:t>
            </a:r>
            <a:r>
              <a:rPr lang="en-US" altLang="ja-JP" sz="1200" b="1" dirty="0"/>
              <a:t>in KCASP1Tg mice treated with JAK inhibitors. The expression of SAA was decreased in the liver of IL-17A</a:t>
            </a:r>
            <a:r>
              <a:rPr lang="en-US" altLang="ja-JP" sz="1200" b="1" baseline="30000" dirty="0"/>
              <a:t>-</a:t>
            </a:r>
            <a:r>
              <a:rPr lang="en-US" altLang="ja-JP" sz="1200" b="1" dirty="0"/>
              <a:t>/KCASP1Tg mice.</a:t>
            </a:r>
            <a:endParaRPr kumimoji="1" lang="en-US" altLang="ja-JP" sz="1200" dirty="0"/>
          </a:p>
          <a:p>
            <a:pPr marL="342900" indent="-342900">
              <a:buAutoNum type="alphaLcParenBoth"/>
            </a:pPr>
            <a:r>
              <a:rPr lang="en-US" altLang="ja-JP" sz="1200" dirty="0"/>
              <a:t>Hematoxylin and eosin staining of the dorsal skin shows epidermal hyperplasia, hyperkeratosis, parakeratosis, spongiosis, and increased infiltration of mixed </a:t>
            </a:r>
          </a:p>
          <a:p>
            <a:r>
              <a:rPr lang="en-US" altLang="ja-JP" sz="1200" dirty="0"/>
              <a:t>inflammatory cells in KCASP1Tg. Histopathologic analysis of the treated with JAK inhibitors skin showed improvement in these skin inflammatory findings. </a:t>
            </a:r>
          </a:p>
          <a:p>
            <a:r>
              <a:rPr lang="en-US" altLang="ja-JP" sz="1200" dirty="0"/>
              <a:t>(b) The expression of SAA in the liver of 0, 8, 16-week-old KCASP1Tg mice , KCASP1Tg mice treated with JAK inhibitors (</a:t>
            </a:r>
            <a:r>
              <a:rPr lang="en-US" altLang="ja-JP" sz="1200" dirty="0" err="1"/>
              <a:t>baricitinib</a:t>
            </a:r>
            <a:r>
              <a:rPr lang="en-US" altLang="ja-JP" sz="1200" dirty="0"/>
              <a:t>, </a:t>
            </a:r>
            <a:r>
              <a:rPr lang="en-US" altLang="ja-JP" sz="1200" dirty="0" err="1"/>
              <a:t>cerdulatinib</a:t>
            </a:r>
            <a:r>
              <a:rPr lang="en-US" altLang="ja-JP" sz="1200" dirty="0"/>
              <a:t>), IL-17A</a:t>
            </a:r>
            <a:r>
              <a:rPr lang="en-US" altLang="ja-JP" sz="1200" baseline="30000" dirty="0"/>
              <a:t>-</a:t>
            </a:r>
            <a:r>
              <a:rPr lang="en-US" altLang="ja-JP" sz="1200" dirty="0"/>
              <a:t>/KCASP1Tg mice</a:t>
            </a:r>
            <a:r>
              <a:rPr lang="ja-JP" altLang="ja-JP" sz="1200"/>
              <a:t> </a:t>
            </a:r>
            <a:r>
              <a:rPr lang="en-US" altLang="ja-JP" sz="1200" dirty="0"/>
              <a:t>were performed (n=5 per group). From 8 to 16 weeks in KCASP1Tg mice, the expression level of SAA was elevated (p values; 0.0002), and was decreased in </a:t>
            </a:r>
          </a:p>
          <a:p>
            <a:r>
              <a:rPr lang="en-US" altLang="ja-JP" sz="1200" dirty="0"/>
              <a:t>IL-17A-/KCASP1Tg mice compared with 16-week-old KCASP1Tg mice (p values; 0.0013). Values are presented as mean ± SD, and statistically significant differences by ordinary one-way ANOVA test.(*; P&lt;0.05, **; P&lt;0.01, ***; P&lt;0.001</a:t>
            </a:r>
            <a:r>
              <a:rPr lang="ja-JP" altLang="ja-JP" sz="1200"/>
              <a:t> </a:t>
            </a:r>
            <a:r>
              <a:rPr lang="en-US" altLang="ja-JP" sz="1200" dirty="0"/>
              <a:t>).</a:t>
            </a:r>
          </a:p>
        </p:txBody>
      </p:sp>
    </p:spTree>
    <p:extLst>
      <p:ext uri="{BB962C8B-B14F-4D97-AF65-F5344CB8AC3E}">
        <p14:creationId xmlns:p14="http://schemas.microsoft.com/office/powerpoint/2010/main" val="2441321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84</TotalTime>
  <Words>385</Words>
  <Application>Microsoft Office PowerPoint</Application>
  <PresentationFormat>Widescreen</PresentationFormat>
  <Paragraphs>24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Office テーマ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飯田 祥平</dc:creator>
  <cp:lastModifiedBy>MDPI</cp:lastModifiedBy>
  <cp:revision>43</cp:revision>
  <dcterms:created xsi:type="dcterms:W3CDTF">2022-05-08T03:54:47Z</dcterms:created>
  <dcterms:modified xsi:type="dcterms:W3CDTF">2022-05-20T11:11:28Z</dcterms:modified>
</cp:coreProperties>
</file>